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50" d="100"/>
          <a:sy n="50" d="100"/>
        </p:scale>
        <p:origin x="-2862" y="-10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141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7462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785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6487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1474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2805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9187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4148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5721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2713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3456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432FC-1397-49BC-B41B-1B8EA2348EC1}" type="datetimeFigureOut">
              <a:rPr lang="it-IT" smtClean="0"/>
              <a:t>20/0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81BFB-36F4-40C2-8A98-2360E0535A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86162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40"/>
          <p:cNvSpPr txBox="1"/>
          <p:nvPr/>
        </p:nvSpPr>
        <p:spPr>
          <a:xfrm>
            <a:off x="7308304" y="6381328"/>
            <a:ext cx="1749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. 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Gruppo 41"/>
          <p:cNvGrpSpPr/>
          <p:nvPr/>
        </p:nvGrpSpPr>
        <p:grpSpPr>
          <a:xfrm>
            <a:off x="1698766" y="915877"/>
            <a:ext cx="6401626" cy="4673363"/>
            <a:chOff x="1698766" y="915877"/>
            <a:chExt cx="6401626" cy="4673363"/>
          </a:xfrm>
        </p:grpSpPr>
        <p:pic>
          <p:nvPicPr>
            <p:cNvPr id="1035" name="Picture 11" descr="C:\Users\Federica\Desktop\ALTRE FOTO\11_61793 TPC\IMAGE006_40X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33000"/>
                      </a14:imgEffect>
                      <a14:imgEffect>
                        <a14:brightnessContrast bright="9000" contras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00930" y="945558"/>
              <a:ext cx="1920000" cy="144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8" name="Picture 14" descr="C:\Users\Federica\Desktop\CMC\CMC MET PAPERO\FOTO CANI new aleR\ER alfa F095 11_65994\IMAGE001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89162" y="945558"/>
              <a:ext cx="1920000" cy="144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Rettangolo 3"/>
            <p:cNvSpPr/>
            <p:nvPr/>
          </p:nvSpPr>
          <p:spPr>
            <a:xfrm>
              <a:off x="1708494" y="954262"/>
              <a:ext cx="187220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e #1 </a:t>
              </a:r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P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9" name="Picture 5" descr="C:\Users\Federica\Desktop\ALTRE FOTO\10_51888 CTPC\IMAGE005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colorTemperature colorTemp="53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91929" y="2521276"/>
              <a:ext cx="1920000" cy="144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C:\Users\Federica\Desktop\ALTRE FOTO\12_20286 NEG AnC\IMAGE000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  <a14:imgEffect>
                        <a14:colorTemperature colorTemp="7200"/>
                      </a14:imgEffect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32518" y="4136781"/>
              <a:ext cx="1920000" cy="144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C:\Users\Federica\Desktop\ALTRE FOTO\10_56540 CC\IMAGE003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25000"/>
                      </a14:imgEffect>
                      <a14:imgEffect>
                        <a14:colorTemperature colorTemp="53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00930" y="2521276"/>
              <a:ext cx="1920000" cy="144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Rettangolo 16"/>
            <p:cNvSpPr/>
            <p:nvPr/>
          </p:nvSpPr>
          <p:spPr>
            <a:xfrm>
              <a:off x="3789162" y="958701"/>
              <a:ext cx="187220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e #2 </a:t>
              </a:r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P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ttangolo 17"/>
            <p:cNvSpPr/>
            <p:nvPr/>
          </p:nvSpPr>
          <p:spPr>
            <a:xfrm>
              <a:off x="1698766" y="2532743"/>
              <a:ext cx="187220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e #3  CC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ttangolo 18"/>
            <p:cNvSpPr/>
            <p:nvPr/>
          </p:nvSpPr>
          <p:spPr>
            <a:xfrm>
              <a:off x="3801384" y="2531040"/>
              <a:ext cx="187220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e #4 CC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ttangolo 19"/>
            <p:cNvSpPr/>
            <p:nvPr/>
          </p:nvSpPr>
          <p:spPr>
            <a:xfrm>
              <a:off x="2745117" y="4136781"/>
              <a:ext cx="187220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e #5 CA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Parentesi quadra chiusa 1"/>
            <p:cNvSpPr/>
            <p:nvPr/>
          </p:nvSpPr>
          <p:spPr>
            <a:xfrm>
              <a:off x="5731214" y="915877"/>
              <a:ext cx="216024" cy="1452459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2" name="Parentesi quadra chiusa 21"/>
            <p:cNvSpPr/>
            <p:nvPr/>
          </p:nvSpPr>
          <p:spPr>
            <a:xfrm>
              <a:off x="5731214" y="2500053"/>
              <a:ext cx="216024" cy="1452459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" name="Parentesi quadra chiusa 22"/>
            <p:cNvSpPr/>
            <p:nvPr/>
          </p:nvSpPr>
          <p:spPr>
            <a:xfrm>
              <a:off x="4674462" y="4136781"/>
              <a:ext cx="216024" cy="1452459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" name="CasellaDiTesto 2"/>
            <p:cNvSpPr txBox="1"/>
            <p:nvPr/>
          </p:nvSpPr>
          <p:spPr>
            <a:xfrm>
              <a:off x="5947238" y="1457440"/>
              <a:ext cx="2153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l-G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ytoplasmic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aining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5947238" y="3056610"/>
              <a:ext cx="18117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l-G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uclear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aining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4903565" y="4678344"/>
              <a:ext cx="18886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l-G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egative </a:t>
              </a:r>
              <a:r>
                <a:rPr lang="it-IT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aining</a:t>
              </a:r>
              <a:r>
                <a:rPr lang="it-IT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Gruppo 11"/>
            <p:cNvGrpSpPr/>
            <p:nvPr/>
          </p:nvGrpSpPr>
          <p:grpSpPr>
            <a:xfrm>
              <a:off x="3254442" y="1124093"/>
              <a:ext cx="288541" cy="148279"/>
              <a:chOff x="3821256" y="920368"/>
              <a:chExt cx="288541" cy="148279"/>
            </a:xfrm>
          </p:grpSpPr>
          <p:sp>
            <p:nvSpPr>
              <p:cNvPr id="27" name="CasellaDiTesto 26"/>
              <p:cNvSpPr txBox="1"/>
              <p:nvPr/>
            </p:nvSpPr>
            <p:spPr>
              <a:xfrm>
                <a:off x="3821256" y="945536"/>
                <a:ext cx="288541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 µm</a:t>
                </a:r>
                <a:endParaRPr 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8" name="Connettore 1 27"/>
              <p:cNvCxnSpPr/>
              <p:nvPr/>
            </p:nvCxnSpPr>
            <p:spPr>
              <a:xfrm>
                <a:off x="3858056" y="920368"/>
                <a:ext cx="227197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" name="Connettore 2 13"/>
            <p:cNvCxnSpPr/>
            <p:nvPr/>
          </p:nvCxnSpPr>
          <p:spPr>
            <a:xfrm flipH="1">
              <a:off x="4435070" y="3272685"/>
              <a:ext cx="182255" cy="20095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ttore 2 43"/>
            <p:cNvCxnSpPr/>
            <p:nvPr/>
          </p:nvCxnSpPr>
          <p:spPr>
            <a:xfrm flipH="1" flipV="1">
              <a:off x="4514723" y="2797671"/>
              <a:ext cx="137795" cy="1507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2 45"/>
            <p:cNvCxnSpPr/>
            <p:nvPr/>
          </p:nvCxnSpPr>
          <p:spPr>
            <a:xfrm flipH="1">
              <a:off x="2855259" y="3005105"/>
              <a:ext cx="211659" cy="13013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2 46"/>
            <p:cNvCxnSpPr/>
            <p:nvPr/>
          </p:nvCxnSpPr>
          <p:spPr>
            <a:xfrm flipH="1">
              <a:off x="3391053" y="3209469"/>
              <a:ext cx="91126" cy="28710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ttore 2 47"/>
            <p:cNvCxnSpPr/>
            <p:nvPr/>
          </p:nvCxnSpPr>
          <p:spPr>
            <a:xfrm flipH="1">
              <a:off x="2550198" y="2969697"/>
              <a:ext cx="182255" cy="20095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ttore 2 48"/>
            <p:cNvCxnSpPr/>
            <p:nvPr/>
          </p:nvCxnSpPr>
          <p:spPr>
            <a:xfrm>
              <a:off x="1914790" y="3333609"/>
              <a:ext cx="216025" cy="18154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ttore 2 49"/>
            <p:cNvCxnSpPr/>
            <p:nvPr/>
          </p:nvCxnSpPr>
          <p:spPr>
            <a:xfrm>
              <a:off x="2130815" y="2816222"/>
              <a:ext cx="144017" cy="18888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ttore 2 50"/>
            <p:cNvCxnSpPr/>
            <p:nvPr/>
          </p:nvCxnSpPr>
          <p:spPr>
            <a:xfrm flipH="1">
              <a:off x="2750094" y="2615268"/>
              <a:ext cx="182255" cy="20095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27749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38</Words>
  <Application>Microsoft Office PowerPoint</Application>
  <PresentationFormat>Presentazione su schermo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ederica</dc:creator>
  <cp:lastModifiedBy>Federica</cp:lastModifiedBy>
  <cp:revision>14</cp:revision>
  <dcterms:created xsi:type="dcterms:W3CDTF">2015-01-20T12:38:41Z</dcterms:created>
  <dcterms:modified xsi:type="dcterms:W3CDTF">2015-01-20T17:08:52Z</dcterms:modified>
</cp:coreProperties>
</file>